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703FF7-D3D5-463A-A68C-09FBE8942A7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EC26AD-B423-41A2-B516-49609A75A3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07093C-C9E0-4A1D-BFD2-C8DD29C65E6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1DF819-A684-4614-9496-DD8964F3CD0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6CA830-48B3-4238-8C11-8B0DFAEA8B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9D28AB-D711-40F4-955A-54D60A4AE6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B9ACD9-C02E-4A1F-95F6-001D6A4A6A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E62A99-A59E-43A9-9D9A-1A84A113B4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10F376-6C63-415F-AD89-2555777D0D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9FD59-2A05-4602-850C-3F9A3E8A85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EB9E57-C034-4301-9427-D31F4DB19F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8D014E-74FC-4D54-AD8E-0C5B91B023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BD80DAC-E2F9-46E6-9A75-705B7E9FB97E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4624F71-A6CB-4FA7-BC6A-9241AA1643C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rcRect l="1724" t="2861" r="4079" b="3885"/>
          <a:stretch/>
        </p:blipFill>
        <p:spPr>
          <a:xfrm>
            <a:off x="1525680" y="2722680"/>
            <a:ext cx="3733560" cy="23526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rcRect l="1724" t="2874" r="2488" b="3110"/>
          <a:stretch/>
        </p:blipFill>
        <p:spPr>
          <a:xfrm>
            <a:off x="1619280" y="5734080"/>
            <a:ext cx="3716280" cy="2243160"/>
          </a:xfrm>
          <a:prstGeom prst="rect">
            <a:avLst/>
          </a:prstGeom>
          <a:ln w="0">
            <a:noFill/>
          </a:ln>
        </p:spPr>
      </p:pic>
      <p:sp>
        <p:nvSpPr>
          <p:cNvPr id="43" name="TextBox 12"/>
          <p:cNvSpPr/>
          <p:nvPr/>
        </p:nvSpPr>
        <p:spPr>
          <a:xfrm rot="16200000">
            <a:off x="242640" y="3650400"/>
            <a:ext cx="220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o. adherent platelets/mm</a:t>
            </a:r>
            <a:r>
              <a:rPr b="0" lang="en-US" sz="14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13"/>
          <p:cNvSpPr/>
          <p:nvPr/>
        </p:nvSpPr>
        <p:spPr>
          <a:xfrm rot="16200000">
            <a:off x="356760" y="6600960"/>
            <a:ext cx="197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Mean surface area (</a:t>
            </a: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m</a:t>
            </a:r>
            <a:r>
              <a:rPr b="0" lang="en-US" sz="14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)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Group 24"/>
          <p:cNvGrpSpPr/>
          <p:nvPr/>
        </p:nvGrpSpPr>
        <p:grpSpPr>
          <a:xfrm>
            <a:off x="2565360" y="2984400"/>
            <a:ext cx="1020960" cy="552600"/>
            <a:chOff x="2565360" y="2984400"/>
            <a:chExt cx="1020960" cy="552600"/>
          </a:xfrm>
        </p:grpSpPr>
        <p:sp>
          <p:nvSpPr>
            <p:cNvPr id="46" name="Straight Connector 14"/>
            <p:cNvSpPr/>
            <p:nvPr/>
          </p:nvSpPr>
          <p:spPr>
            <a:xfrm>
              <a:off x="2565360" y="2984400"/>
              <a:ext cx="1020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Straight Connector 19"/>
            <p:cNvSpPr/>
            <p:nvPr/>
          </p:nvSpPr>
          <p:spPr>
            <a:xfrm>
              <a:off x="2565360" y="2984400"/>
              <a:ext cx="0" cy="133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Straight Connector 22"/>
            <p:cNvSpPr/>
            <p:nvPr/>
          </p:nvSpPr>
          <p:spPr>
            <a:xfrm>
              <a:off x="3586320" y="2984400"/>
              <a:ext cx="0" cy="552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9" name="Group 25"/>
          <p:cNvGrpSpPr/>
          <p:nvPr/>
        </p:nvGrpSpPr>
        <p:grpSpPr>
          <a:xfrm>
            <a:off x="3659040" y="2984400"/>
            <a:ext cx="1022400" cy="552600"/>
            <a:chOff x="3659040" y="2984400"/>
            <a:chExt cx="1022400" cy="552600"/>
          </a:xfrm>
        </p:grpSpPr>
        <p:sp>
          <p:nvSpPr>
            <p:cNvPr id="50" name="Straight Connector 26"/>
            <p:cNvSpPr/>
            <p:nvPr/>
          </p:nvSpPr>
          <p:spPr>
            <a:xfrm flipH="1">
              <a:off x="3659040" y="2984400"/>
              <a:ext cx="10224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Straight Connector 27"/>
            <p:cNvSpPr/>
            <p:nvPr/>
          </p:nvSpPr>
          <p:spPr>
            <a:xfrm>
              <a:off x="4681440" y="2984400"/>
              <a:ext cx="0" cy="133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Straight Connector 28"/>
            <p:cNvSpPr/>
            <p:nvPr/>
          </p:nvSpPr>
          <p:spPr>
            <a:xfrm>
              <a:off x="3659040" y="2984400"/>
              <a:ext cx="0" cy="552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TextBox 29"/>
          <p:cNvSpPr/>
          <p:nvPr/>
        </p:nvSpPr>
        <p:spPr>
          <a:xfrm>
            <a:off x="2911680" y="2722680"/>
            <a:ext cx="26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30"/>
          <p:cNvSpPr/>
          <p:nvPr/>
        </p:nvSpPr>
        <p:spPr>
          <a:xfrm>
            <a:off x="4021560" y="2722680"/>
            <a:ext cx="26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6"/>
          <p:cNvSpPr/>
          <p:nvPr/>
        </p:nvSpPr>
        <p:spPr>
          <a:xfrm>
            <a:off x="3395520" y="4917960"/>
            <a:ext cx="52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Pred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8"/>
          <p:cNvSpPr/>
          <p:nvPr/>
        </p:nvSpPr>
        <p:spPr>
          <a:xfrm>
            <a:off x="4415400" y="4951440"/>
            <a:ext cx="666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Pred+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RU486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3"/>
          <p:cNvSpPr/>
          <p:nvPr/>
        </p:nvSpPr>
        <p:spPr>
          <a:xfrm>
            <a:off x="825480" y="2273400"/>
            <a:ext cx="20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4"/>
          <p:cNvSpPr/>
          <p:nvPr/>
        </p:nvSpPr>
        <p:spPr>
          <a:xfrm>
            <a:off x="1028880" y="5424480"/>
            <a:ext cx="203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6"/>
          <p:cNvSpPr/>
          <p:nvPr/>
        </p:nvSpPr>
        <p:spPr>
          <a:xfrm>
            <a:off x="3395520" y="7977240"/>
            <a:ext cx="52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Pred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8"/>
          <p:cNvSpPr/>
          <p:nvPr/>
        </p:nvSpPr>
        <p:spPr>
          <a:xfrm>
            <a:off x="4415400" y="8010360"/>
            <a:ext cx="666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Pred+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RU486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65"/>
          <p:cNvSpPr/>
          <p:nvPr/>
        </p:nvSpPr>
        <p:spPr>
          <a:xfrm>
            <a:off x="2142000" y="5011560"/>
            <a:ext cx="858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brinogen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lone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65"/>
          <p:cNvSpPr/>
          <p:nvPr/>
        </p:nvSpPr>
        <p:spPr>
          <a:xfrm>
            <a:off x="2142000" y="7977240"/>
            <a:ext cx="858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brinogen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lone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1"/>
          <p:cNvSpPr/>
          <p:nvPr/>
        </p:nvSpPr>
        <p:spPr>
          <a:xfrm>
            <a:off x="131760" y="181080"/>
            <a:ext cx="6485040" cy="1769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upplementary Figure 1. Prednisolone potently inhibits platelet adhesion and spreading on fibrinogen. 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Glass slides were coated overnight at 4°C with fibrinogen (100mg/ml), or heat-denatured human serum. Uncoated surfaces were blocked by overlay with heat inactivated human serum albumin (HSA, 5%) for 30min at 20°C. Washed platelets (5×10</a:t>
            </a:r>
            <a:r>
              <a:rPr b="1" lang="en-GB" sz="1000" spc="-1" strike="noStrike" baseline="30000">
                <a:solidFill>
                  <a:srgbClr val="000000"/>
                </a:solidFill>
                <a:latin typeface="Arial"/>
              </a:rPr>
              <a:t>7 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platelets/mL)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were pre-incubated with Pred (5min – 1µM) in the presence or absence of RU486 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and adhered for 30 min, stained with TRITC-phalloidin and viewed using the ×60 magnification. (A) Platelets from 8 random visual fields with a total area of 0.1mm</a:t>
            </a:r>
            <a:r>
              <a:rPr b="1" lang="en-GB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 were counted and expressed as number of adherent platelets/0.1mm</a:t>
            </a:r>
            <a:r>
              <a:rPr b="1" lang="en-GB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. A significant decrease in platelet adhesion is observed following Pred pre-incubation. *</a:t>
            </a: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&lt;0.05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compared to fibrinogen alone and compared to RU486.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 (B) These images were used to determine platelet surface area, presented the mean surface area (μm</a:t>
            </a:r>
            <a:r>
              <a:rPr b="1" lang="en-GB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). No difference was noted in platelet spreading between treated and controls. All data shown are means ± SEM, n=5 with separate blood donors.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4" name="Group 22"/>
          <p:cNvGrpSpPr/>
          <p:nvPr/>
        </p:nvGrpSpPr>
        <p:grpSpPr>
          <a:xfrm>
            <a:off x="1190520" y="2476440"/>
            <a:ext cx="4267440" cy="2580840"/>
            <a:chOff x="1190520" y="2476440"/>
            <a:chExt cx="4267440" cy="2580840"/>
          </a:xfrm>
        </p:grpSpPr>
        <p:pic>
          <p:nvPicPr>
            <p:cNvPr id="65" name="Picture 34" descr=""/>
            <p:cNvPicPr/>
            <p:nvPr/>
          </p:nvPicPr>
          <p:blipFill>
            <a:blip r:embed="rId1"/>
            <a:stretch/>
          </p:blipFill>
          <p:spPr>
            <a:xfrm>
              <a:off x="1817640" y="2476440"/>
              <a:ext cx="3640320" cy="2290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Text Box 17"/>
            <p:cNvSpPr/>
            <p:nvPr/>
          </p:nvSpPr>
          <p:spPr>
            <a:xfrm>
              <a:off x="1246320" y="3946680"/>
              <a:ext cx="825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Verdana"/>
                  <a:ea typeface="Arial"/>
                </a:rPr>
                <a:t>PRED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18"/>
            <p:cNvSpPr/>
            <p:nvPr/>
          </p:nvSpPr>
          <p:spPr>
            <a:xfrm>
              <a:off x="1190520" y="2787480"/>
              <a:ext cx="8812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Verdana"/>
                  <a:ea typeface="Arial"/>
                </a:rPr>
                <a:t>PRED + PGE1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19"/>
            <p:cNvSpPr/>
            <p:nvPr/>
          </p:nvSpPr>
          <p:spPr>
            <a:xfrm>
              <a:off x="1411200" y="3389400"/>
              <a:ext cx="660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Verdana"/>
                  <a:ea typeface="Arial"/>
                </a:rPr>
                <a:t>PGE1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34"/>
            <p:cNvSpPr/>
            <p:nvPr/>
          </p:nvSpPr>
          <p:spPr>
            <a:xfrm>
              <a:off x="4517280" y="2894040"/>
              <a:ext cx="320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35"/>
            <p:cNvSpPr/>
            <p:nvPr/>
          </p:nvSpPr>
          <p:spPr>
            <a:xfrm>
              <a:off x="4058280" y="3362400"/>
              <a:ext cx="320760" cy="489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#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36"/>
            <p:cNvSpPr/>
            <p:nvPr/>
          </p:nvSpPr>
          <p:spPr>
            <a:xfrm>
              <a:off x="2841480" y="398772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5"/>
            <p:cNvSpPr/>
            <p:nvPr/>
          </p:nvSpPr>
          <p:spPr>
            <a:xfrm rot="12000">
              <a:off x="1896840" y="4774680"/>
              <a:ext cx="345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Verdana"/>
                  <a:ea typeface="Arial"/>
                </a:rPr>
                <a:t>Platelet Aggregation (% Inhibition)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3" name="Rectangle 1"/>
          <p:cNvSpPr/>
          <p:nvPr/>
        </p:nvSpPr>
        <p:spPr>
          <a:xfrm>
            <a:off x="27000" y="176040"/>
            <a:ext cx="6831000" cy="16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2. Prednisolone does not affect platelet cAMP levels. Platelet aggregation was assessed in whole blood aggregometer. Samples were pre-incubated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with either both Pred (10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), and Prostaglandin E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(9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) or single compound exposure before ADP (3.25 µM) induced activation. Results are shown as percentage of inhibition compared with untreated samples. Both Prednisolone and Prostaglandin E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1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uld inhibit platelet aggregation and they showed additive effect when added together, indicating that they probably act through distinct pathways.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All data shown are means ± SEM, n=5 with separate blood donors. 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9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27T16:29:58Z</dcterms:created>
  <dc:creator>Office 2004 Test Drive User</dc:creator>
  <dc:description/>
  <dc:language>en-US</dc:language>
  <cp:lastModifiedBy>57058</cp:lastModifiedBy>
  <dcterms:modified xsi:type="dcterms:W3CDTF">2012-02-22T05:54:26Z</dcterms:modified>
  <cp:revision>73</cp:revision>
  <dc:subject/>
  <dc:title>Slide 1</dc:title>
</cp:coreProperties>
</file>